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2586" y="4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485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035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510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448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835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788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871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518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52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550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793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2FCAF-C477-4CDD-B62C-D96D95385219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EFDC6-9024-499B-9050-934095CA7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454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79041" y="8458200"/>
            <a:ext cx="3462107" cy="457200"/>
          </a:xfrm>
        </p:spPr>
        <p:txBody>
          <a:bodyPr>
            <a:noAutofit/>
          </a:bodyPr>
          <a:lstStyle/>
          <a:p>
            <a:r>
              <a:rPr lang="en-US" sz="2000" dirty="0">
                <a:solidFill>
                  <a:schemeClr val="tx1"/>
                </a:solidFill>
              </a:rPr>
              <a:t>F</a:t>
            </a:r>
            <a:r>
              <a:rPr lang="en-US" sz="2000" dirty="0" smtClean="0">
                <a:solidFill>
                  <a:schemeClr val="tx1"/>
                </a:solidFill>
              </a:rPr>
              <a:t>igure S3 </a:t>
            </a:r>
            <a:r>
              <a:rPr lang="en-US" sz="2000" dirty="0">
                <a:solidFill>
                  <a:schemeClr val="tx1"/>
                </a:solidFill>
              </a:rPr>
              <a:t>Kanno et al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98" r="8220"/>
          <a:stretch/>
        </p:blipFill>
        <p:spPr>
          <a:xfrm>
            <a:off x="1177653" y="685800"/>
            <a:ext cx="4495800" cy="431833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147198" y="5097460"/>
            <a:ext cx="2840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2895600" y="5004134"/>
            <a:ext cx="9637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/>
              <a:t>prp18a-1</a:t>
            </a:r>
          </a:p>
          <a:p>
            <a:r>
              <a:rPr lang="en-US" sz="1600" dirty="0"/>
              <a:t>+ </a:t>
            </a:r>
            <a:r>
              <a:rPr lang="en-US" sz="1600" i="1" dirty="0"/>
              <a:t>PRP18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62400" y="5002706"/>
            <a:ext cx="947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/>
              <a:t>prp18a-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90600" y="6172200"/>
            <a:ext cx="51054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Phenotypes of adult plants</a:t>
            </a:r>
          </a:p>
          <a:p>
            <a:pPr>
              <a:lnSpc>
                <a:spcPct val="150000"/>
              </a:lnSpc>
            </a:pP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ult plants of the wild-type T line,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a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utant, and a complemented line 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a-1 + PRP18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have a similar overall appearance. When photographed, the plants were the same age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grow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der identical conditions.</a:t>
            </a:r>
          </a:p>
          <a:p>
            <a:pPr>
              <a:lnSpc>
                <a:spcPct val="150000"/>
              </a:lnSpc>
            </a:pP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44856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9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6</cp:revision>
  <dcterms:created xsi:type="dcterms:W3CDTF">2017-09-29T06:49:33Z</dcterms:created>
  <dcterms:modified xsi:type="dcterms:W3CDTF">2017-11-05T06:33:37Z</dcterms:modified>
</cp:coreProperties>
</file>